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図 73"/>
          <p:cNvPicPr>
            <a:picLocks noChangeAspect="1"/>
          </p:cNvPicPr>
          <p:nvPr/>
        </p:nvPicPr>
        <p:blipFill>
          <a:blip r:embed="rId2"/>
          <a:srcRect t="18731"/>
          <a:stretch>
            <a:fillRect/>
          </a:stretch>
        </p:blipFill>
        <p:spPr>
          <a:xfrm>
            <a:off x="1036834" y="2747080"/>
            <a:ext cx="2577084" cy="1335457"/>
          </a:xfrm>
          <a:prstGeom prst="rect">
            <a:avLst/>
          </a:prstGeom>
        </p:spPr>
      </p:pic>
      <p:pic>
        <p:nvPicPr>
          <p:cNvPr id="32" name="図 31"/>
          <p:cNvPicPr>
            <a:picLocks noChangeAspect="1"/>
          </p:cNvPicPr>
          <p:nvPr/>
        </p:nvPicPr>
        <p:blipFill>
          <a:blip r:embed="rId3"/>
          <a:srcRect t="22677"/>
          <a:stretch>
            <a:fillRect/>
          </a:stretch>
        </p:blipFill>
        <p:spPr>
          <a:xfrm>
            <a:off x="974897" y="4584063"/>
            <a:ext cx="2417826" cy="1399368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4"/>
          <a:srcRect t="22677"/>
          <a:stretch>
            <a:fillRect/>
          </a:stretch>
        </p:blipFill>
        <p:spPr>
          <a:xfrm>
            <a:off x="3548295" y="4584063"/>
            <a:ext cx="2417826" cy="1399368"/>
          </a:xfrm>
          <a:prstGeom prst="rect">
            <a:avLst/>
          </a:prstGeom>
        </p:spPr>
      </p:pic>
      <p:sp>
        <p:nvSpPr>
          <p:cNvPr id="37" name="テキスト ボックス 36"/>
          <p:cNvSpPr txBox="1"/>
          <p:nvPr/>
        </p:nvSpPr>
        <p:spPr>
          <a:xfrm>
            <a:off x="692733" y="428151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c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692733" y="2493900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959525" y="4409655"/>
            <a:ext cx="6480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Placebo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4469894" y="4409655"/>
            <a:ext cx="7763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 smtClean="0">
                <a:latin typeface="Arial"/>
                <a:cs typeface="Arial"/>
              </a:rPr>
              <a:t>Fluoxetine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8" name="正方形/長方形 47"/>
          <p:cNvSpPr/>
          <p:nvPr/>
        </p:nvSpPr>
        <p:spPr>
          <a:xfrm>
            <a:off x="1989797" y="5575447"/>
            <a:ext cx="194400" cy="64800"/>
          </a:xfrm>
          <a:prstGeom prst="rect">
            <a:avLst/>
          </a:prstGeom>
          <a:solidFill>
            <a:schemeClr val="bg1"/>
          </a:solidFill>
          <a:ln w="63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/>
          <p:cNvSpPr/>
          <p:nvPr/>
        </p:nvSpPr>
        <p:spPr>
          <a:xfrm>
            <a:off x="4563101" y="5575447"/>
            <a:ext cx="194400" cy="64800"/>
          </a:xfrm>
          <a:prstGeom prst="rect">
            <a:avLst/>
          </a:prstGeom>
          <a:solidFill>
            <a:schemeClr val="bg1"/>
          </a:solidFill>
          <a:ln w="63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018376" y="5720362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5590815" y="5720362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825471" y="5394928"/>
            <a:ext cx="5097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novelty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405488" y="5394928"/>
            <a:ext cx="5097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novelty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021249" y="4703500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240847" y="4763110"/>
            <a:ext cx="2844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4642678" y="4655875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840051" y="4671035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cxnSp>
        <p:nvCxnSpPr>
          <p:cNvPr id="52" name="直線コネクタ 51"/>
          <p:cNvCxnSpPr/>
          <p:nvPr/>
        </p:nvCxnSpPr>
        <p:spPr>
          <a:xfrm>
            <a:off x="1552540" y="4051518"/>
            <a:ext cx="396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2070997" y="4051518"/>
            <a:ext cx="396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/>
          <p:cNvSpPr txBox="1"/>
          <p:nvPr/>
        </p:nvSpPr>
        <p:spPr>
          <a:xfrm>
            <a:off x="1581115" y="402529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DA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994349" y="4025294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DOPAC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56" name="直線コネクタ 55"/>
          <p:cNvCxnSpPr/>
          <p:nvPr/>
        </p:nvCxnSpPr>
        <p:spPr>
          <a:xfrm>
            <a:off x="2576636" y="4051518"/>
            <a:ext cx="396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2576188" y="4025294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HVA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grpSp>
        <p:nvGrpSpPr>
          <p:cNvPr id="42" name="図形グループ 41"/>
          <p:cNvGrpSpPr/>
          <p:nvPr/>
        </p:nvGrpSpPr>
        <p:grpSpPr>
          <a:xfrm>
            <a:off x="2600473" y="2908952"/>
            <a:ext cx="379907" cy="355733"/>
            <a:chOff x="2690195" y="5321062"/>
            <a:chExt cx="379907" cy="355733"/>
          </a:xfrm>
        </p:grpSpPr>
        <p:sp>
          <p:nvSpPr>
            <p:cNvPr id="43" name="正方形/長方形 42"/>
            <p:cNvSpPr/>
            <p:nvPr/>
          </p:nvSpPr>
          <p:spPr>
            <a:xfrm>
              <a:off x="2690195" y="5399839"/>
              <a:ext cx="57891" cy="57891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正方形/長方形 44"/>
            <p:cNvSpPr/>
            <p:nvPr/>
          </p:nvSpPr>
          <p:spPr>
            <a:xfrm>
              <a:off x="2690195" y="5540128"/>
              <a:ext cx="57891" cy="57891"/>
            </a:xfrm>
            <a:prstGeom prst="rect">
              <a:avLst/>
            </a:prstGeom>
            <a:solidFill>
              <a:srgbClr val="CBEFFE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2693076" y="5321062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PL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2693076" y="5461351"/>
              <a:ext cx="3770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 smtClean="0">
                  <a:latin typeface="Arial"/>
                  <a:cs typeface="Arial"/>
                </a:rPr>
                <a:t>FLX</a:t>
              </a:r>
              <a:endParaRPr kumimoji="1" lang="ja-JP" altLang="en-US" sz="800" dirty="0">
                <a:latin typeface="Arial"/>
                <a:cs typeface="Arial"/>
              </a:endParaRPr>
            </a:p>
          </p:txBody>
        </p:sp>
      </p:grpSp>
      <p:sp>
        <p:nvSpPr>
          <p:cNvPr id="31" name="テキスト ボックス 30"/>
          <p:cNvSpPr txBox="1"/>
          <p:nvPr/>
        </p:nvSpPr>
        <p:spPr>
          <a:xfrm>
            <a:off x="194735" y="6316632"/>
            <a:ext cx="647999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6.</a:t>
            </a:r>
            <a:endParaRPr lang="en-US" altLang="ja-JP" sz="1200" dirty="0" smtClean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a)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Effects of acute fluoxetine administration on 5-HT levels in the dentat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gyrus.</a:t>
            </a:r>
          </a:p>
          <a:p>
            <a:pPr algn="just"/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Effects of acute systemic administration of fluoxetine (10 mg/kg,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i.p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; n = 6) or saline (n = 6) on 5-HT level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 dialysates from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 dentate gyrus of untreated mice.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ata are expressed as the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S.E.M.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*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0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vs. the basal levels of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5-HT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 the same group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</a:p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b, c) Effects of chronic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fluoxetine treatment on the dopamine response to novelty stress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)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Basal values of extracellular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opamine (DA), 3,4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-dihydroxyphenylacetic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cid (DOPAC) and homovanillic acid (HVA)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were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etermined by microdialysis in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 dentate gyrus of placebo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PL) or fluoxetine (FLX; 15 mg/kg/day for 14 days)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ellet-treated mice.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c)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ffects of novelty stress on dopamine levels in dialysates from the dentate gyrus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of placebo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n = 6) or fluoxetine (n = 5)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ellet-treated mice.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ll values are calculated as a percentage of the basal values within the same group (100%). All mice received an infusion of Ringer’s solution into the dentat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gyru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as th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perfusate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of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microdialysi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probe. The open squares indicate the 30 min of exposure to novel environment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Data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re expressed as the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S.E.M.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5, 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1,  *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01 vs. the basal levels of dopamine in the same group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92733" y="673112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pic>
        <p:nvPicPr>
          <p:cNvPr id="35" name="図 34"/>
          <p:cNvPicPr>
            <a:picLocks noChangeAspect="1"/>
          </p:cNvPicPr>
          <p:nvPr/>
        </p:nvPicPr>
        <p:blipFill>
          <a:blip r:embed="rId5"/>
          <a:srcRect t="14462"/>
          <a:stretch>
            <a:fillRect/>
          </a:stretch>
        </p:blipFill>
        <p:spPr>
          <a:xfrm>
            <a:off x="968762" y="909688"/>
            <a:ext cx="2417826" cy="1517042"/>
          </a:xfrm>
          <a:prstGeom prst="rect">
            <a:avLst/>
          </a:prstGeom>
        </p:spPr>
      </p:pic>
      <p:sp>
        <p:nvSpPr>
          <p:cNvPr id="39" name="テキスト ボックス 38"/>
          <p:cNvSpPr txBox="1"/>
          <p:nvPr/>
        </p:nvSpPr>
        <p:spPr>
          <a:xfrm>
            <a:off x="3005676" y="2152177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0" name="円/楕円 39"/>
          <p:cNvSpPr/>
          <p:nvPr/>
        </p:nvSpPr>
        <p:spPr>
          <a:xfrm>
            <a:off x="1608022" y="1157292"/>
            <a:ext cx="64319" cy="64319"/>
          </a:xfrm>
          <a:prstGeom prst="ellipse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615199" y="108172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AL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615199" y="1222018"/>
            <a:ext cx="377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FLX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3" name="円/楕円 62"/>
          <p:cNvSpPr/>
          <p:nvPr/>
        </p:nvSpPr>
        <p:spPr>
          <a:xfrm>
            <a:off x="1608022" y="1297173"/>
            <a:ext cx="64319" cy="64319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012334" y="1115271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208995" y="1061296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402262" y="1007321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2598476" y="943821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792484" y="1053154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cxnSp>
        <p:nvCxnSpPr>
          <p:cNvPr id="75" name="直線コネクタ 74"/>
          <p:cNvCxnSpPr/>
          <p:nvPr/>
        </p:nvCxnSpPr>
        <p:spPr>
          <a:xfrm rot="5400000" flipH="1" flipV="1">
            <a:off x="1927051" y="1938134"/>
            <a:ext cx="229021" cy="1588"/>
          </a:xfrm>
          <a:prstGeom prst="line">
            <a:avLst/>
          </a:prstGeom>
          <a:ln w="15875">
            <a:solidFill>
              <a:schemeClr val="tx1"/>
            </a:solidFill>
            <a:tailEnd type="triangle" w="sm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/>
          <p:cNvSpPr txBox="1"/>
          <p:nvPr/>
        </p:nvSpPr>
        <p:spPr>
          <a:xfrm>
            <a:off x="2040544" y="1901808"/>
            <a:ext cx="9050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SAL or FLX, </a:t>
            </a:r>
            <a:r>
              <a:rPr kumimoji="1" lang="en-US" altLang="ja-JP" sz="800" dirty="0" err="1" smtClean="0">
                <a:latin typeface="Arial"/>
                <a:cs typeface="Arial"/>
              </a:rPr>
              <a:t>i.p</a:t>
            </a:r>
            <a:r>
              <a:rPr kumimoji="1" lang="en-US" altLang="ja-JP" sz="800" dirty="0" smtClean="0">
                <a:latin typeface="Arial"/>
                <a:cs typeface="Arial"/>
              </a:rPr>
              <a:t>.</a:t>
            </a:r>
            <a:endParaRPr kumimoji="1" lang="ja-JP" alt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424167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345</Words>
  <Application>Microsoft Macintosh PowerPoint</Application>
  <PresentationFormat>A4 210x297 mm</PresentationFormat>
  <Paragraphs>3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30:53Z</dcterms:modified>
  <cp:category/>
</cp:coreProperties>
</file>